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57" r:id="rId5"/>
    <p:sldId id="259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>
        <p:scale>
          <a:sx n="75" d="100"/>
          <a:sy n="75" d="100"/>
        </p:scale>
        <p:origin x="690" y="3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C889A6-E87D-44CA-8676-A184018E0F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482197D-2806-4CE6-931E-126AAE256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BF90BB-F353-4767-ACDE-A1478CD66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186FED-6F9D-4DF6-BA29-B4682F4C1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617744-DF95-4171-858F-6BBB1D2EF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7728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466909-F418-4C2F-BE80-3EC092A71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19F7B62-0A94-42AC-B05E-7C0D61FA5F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D540A2-167B-4FCE-B058-526B2ED46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6D010B7-6851-413E-AA67-BDB0F7937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AC64397-E89E-46BE-83B1-CC0EF1C73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3364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23159E7-AF26-461D-8C7C-0BE420D08E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CD97C76-FCE3-451B-BEA3-A7E253894E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7CBEA0-DD70-4DDD-AED7-05CF617D42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7863D8-04D0-4A59-8288-916900303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E7A86B-04B8-4BED-B7C0-D5C4B9DEB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4329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710A14-A23E-423D-8086-C4838ED73F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46495CD-19DC-4686-821D-09C68E79AE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B75A1D-7595-4729-9CE1-2AEDCD865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8C17E9-1D4D-4B14-84AD-15DC76B7A6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F2A561-BA02-40B6-84AD-FC23544A1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5323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738C6C-919A-4F8A-83C7-138E3B19A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6791CD1-72E5-4F6A-A508-19C5EF09D1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A5AAD8-ADE0-42FA-AD16-637BD4E5D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5CD6B2-82D2-4338-B003-9173C317F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3F88E7-56D9-4E43-BFF3-72B9C1C421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9700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32E69D-8AF7-486A-967C-53F736EAD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264B95-5D21-44F0-903B-DB649CA8B4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301295A-E7B5-474D-9243-D1D540B8C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FEAE44E-7393-4F55-BBD5-5BAD8FC6B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03365AE-F801-4D72-9487-97CF1DC65F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FB20C6E-D423-4F55-9C21-4E9C27743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9018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9E2364-682E-4846-B5B7-5254CCBE84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29787F-C5AE-45CD-BF22-2101E7B93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A54B442-FDFC-47EF-859F-B89518B903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4413237-8455-4617-B97D-21C751CAC15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7351367-AFFC-464B-A97A-96B733DFAB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DF284F2-DC66-4F45-B337-4281E049D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F50447B-B71A-4A02-83A0-B3159F123E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1BFBA4A-1990-49C2-9EA4-F1144086E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5287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279D8C4-157A-4924-848C-C448EF60C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44A9498-CA85-40A1-945D-257F98D88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FEA8367-8F32-4998-B181-9B10C2AE5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FD0E827-BE2C-4919-9D98-B1F641DC7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874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F5B6DE3-A636-4B5C-A325-0B6311C4C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6B9870F-CE4C-4964-816E-E507F394F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99F9ABB-49CC-49A4-A1B2-147A7097E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1347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83095E-92E4-4685-82C8-B9DF841ED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458B45A-CE57-4AE7-A70E-B44624CC5A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F584F27-271F-4283-B33A-3C570D6F45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40317E-C63B-4B22-B8F6-C1CF47AE0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9A53572-95B3-44CE-8F4E-729DA658E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9CC4E8D-FB90-4F0E-B8C4-7CEF9A4FA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964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13CDFA-03DB-4A12-8F5F-6CCD02F45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8A6619E-6251-418E-9995-F48A6DD3CA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5E2AC9A-63EA-4E84-A002-00E5E98333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A98549E-ABBF-4BF9-A938-494005EEA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C4AFAB-06F3-4F89-B941-3D135215D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FD2C6BE-CBD3-45D0-B7C5-112FE9EA6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2929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12797CE-23AB-4C95-9652-E4D7F5952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EA600BC-8FFC-41AC-BC3F-938744644A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15842C-FA51-4419-9E44-E22209BBE7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9B7BF-A4D2-43CE-80C8-FEDC07685C80}" type="datetimeFigureOut">
              <a:rPr lang="zh-CN" altLang="en-US" smtClean="0"/>
              <a:t>2021/12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47C2E4D-32D9-47EA-A0BA-9446FC6CAF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3B8D57-960D-4C46-B57E-35B1CAB934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3A67-E3E6-4AFD-88B3-4B1E6BCD9F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854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5.png"/><Relationship Id="rId5" Type="http://schemas.openxmlformats.org/officeDocument/2006/relationships/image" Target="../media/image10.png"/><Relationship Id="rId10" Type="http://schemas.openxmlformats.org/officeDocument/2006/relationships/image" Target="../media/image14.png"/><Relationship Id="rId4" Type="http://schemas.openxmlformats.org/officeDocument/2006/relationships/image" Target="../media/image9.png"/><Relationship Id="rId9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11.png"/><Relationship Id="rId7" Type="http://schemas.openxmlformats.org/officeDocument/2006/relationships/image" Target="../media/image33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12.png"/><Relationship Id="rId9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7" Type="http://schemas.openxmlformats.org/officeDocument/2006/relationships/image" Target="../media/image37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7" Type="http://schemas.openxmlformats.org/officeDocument/2006/relationships/image" Target="../media/image49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png"/><Relationship Id="rId5" Type="http://schemas.openxmlformats.org/officeDocument/2006/relationships/image" Target="../media/image47.png"/><Relationship Id="rId4" Type="http://schemas.openxmlformats.org/officeDocument/2006/relationships/image" Target="../media/image46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3063CD9-9F6B-4852-8628-A9370574140C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A03607A-7B54-493F-890C-6EDB1F978EE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46" t="24172" r="12947" b="50174"/>
          <a:stretch/>
        </p:blipFill>
        <p:spPr>
          <a:xfrm>
            <a:off x="1649893" y="1704960"/>
            <a:ext cx="3256238" cy="59355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A6B475D-49F0-4F3E-9B3F-EF8A0CCB1A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84866" y="2425515"/>
            <a:ext cx="3208947" cy="461665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8910D6FD-7567-40A4-9DCA-9AE04F4E52CC}"/>
              </a:ext>
            </a:extLst>
          </p:cNvPr>
          <p:cNvSpPr/>
          <p:nvPr/>
        </p:nvSpPr>
        <p:spPr>
          <a:xfrm>
            <a:off x="3469051" y="1575904"/>
            <a:ext cx="1324762" cy="143827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8115211-CE5F-48B5-B5D7-DB945137CFB2}"/>
              </a:ext>
            </a:extLst>
          </p:cNvPr>
          <p:cNvSpPr txBox="1"/>
          <p:nvPr/>
        </p:nvSpPr>
        <p:spPr>
          <a:xfrm rot="18554512">
            <a:off x="2152357" y="104945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E6E6773-E5B0-4CEA-8990-AAFFC0A65070}"/>
              </a:ext>
            </a:extLst>
          </p:cNvPr>
          <p:cNvSpPr txBox="1"/>
          <p:nvPr/>
        </p:nvSpPr>
        <p:spPr>
          <a:xfrm rot="18554512">
            <a:off x="2562908" y="103178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E46AE32-7B94-483C-B05D-0C3251A01DBD}"/>
              </a:ext>
            </a:extLst>
          </p:cNvPr>
          <p:cNvSpPr txBox="1"/>
          <p:nvPr/>
        </p:nvSpPr>
        <p:spPr>
          <a:xfrm rot="18554512">
            <a:off x="2973459" y="101411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BE55309-6AC9-44CB-994D-7DCB3C16DFEB}"/>
              </a:ext>
            </a:extLst>
          </p:cNvPr>
          <p:cNvSpPr txBox="1"/>
          <p:nvPr/>
        </p:nvSpPr>
        <p:spPr>
          <a:xfrm rot="18554512">
            <a:off x="3433079" y="106097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D0AAD89-17BD-4BF6-8A2B-4F17FB678F6E}"/>
              </a:ext>
            </a:extLst>
          </p:cNvPr>
          <p:cNvSpPr txBox="1"/>
          <p:nvPr/>
        </p:nvSpPr>
        <p:spPr>
          <a:xfrm rot="18554512">
            <a:off x="3843630" y="104329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257CC62-CE4F-4D30-95DF-6599C1C5A086}"/>
              </a:ext>
            </a:extLst>
          </p:cNvPr>
          <p:cNvSpPr txBox="1"/>
          <p:nvPr/>
        </p:nvSpPr>
        <p:spPr>
          <a:xfrm rot="18554512">
            <a:off x="4254181" y="102562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867E1905-600B-474C-ADA8-F25F515D5D2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7314"/>
          <a:stretch/>
        </p:blipFill>
        <p:spPr>
          <a:xfrm>
            <a:off x="6743642" y="1669619"/>
            <a:ext cx="3375238" cy="701147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F28997DC-DE5D-40B9-A61B-AFC5A79CF3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12971" y="2487317"/>
            <a:ext cx="3192131" cy="399863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BAA5299F-8CFA-4540-A879-2A154BB75974}"/>
              </a:ext>
            </a:extLst>
          </p:cNvPr>
          <p:cNvSpPr/>
          <p:nvPr/>
        </p:nvSpPr>
        <p:spPr>
          <a:xfrm>
            <a:off x="6821846" y="1575904"/>
            <a:ext cx="1308986" cy="143827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92922BB3-862E-4A7A-80A3-B42832F21BAE}"/>
              </a:ext>
            </a:extLst>
          </p:cNvPr>
          <p:cNvSpPr/>
          <p:nvPr/>
        </p:nvSpPr>
        <p:spPr>
          <a:xfrm>
            <a:off x="8148673" y="1575904"/>
            <a:ext cx="1308986" cy="143827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F87E9BD-025A-4B55-92F6-06532E167BED}"/>
              </a:ext>
            </a:extLst>
          </p:cNvPr>
          <p:cNvSpPr txBox="1"/>
          <p:nvPr/>
        </p:nvSpPr>
        <p:spPr>
          <a:xfrm rot="18554512">
            <a:off x="6727403" y="100309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218AFB8-03D3-4CB8-971A-C8A13E057675}"/>
              </a:ext>
            </a:extLst>
          </p:cNvPr>
          <p:cNvSpPr txBox="1"/>
          <p:nvPr/>
        </p:nvSpPr>
        <p:spPr>
          <a:xfrm rot="18554512">
            <a:off x="7137954" y="98541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B9303C4-EE10-4BCE-BFE1-AD0448640277}"/>
              </a:ext>
            </a:extLst>
          </p:cNvPr>
          <p:cNvSpPr txBox="1"/>
          <p:nvPr/>
        </p:nvSpPr>
        <p:spPr>
          <a:xfrm rot="18554512">
            <a:off x="7548505" y="96774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4F81A29-CD30-4075-89A2-9C4E224D9EFE}"/>
              </a:ext>
            </a:extLst>
          </p:cNvPr>
          <p:cNvSpPr txBox="1"/>
          <p:nvPr/>
        </p:nvSpPr>
        <p:spPr>
          <a:xfrm rot="18554512">
            <a:off x="8008125" y="101460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301B71B-3E51-436C-9993-A70144B3D87D}"/>
              </a:ext>
            </a:extLst>
          </p:cNvPr>
          <p:cNvSpPr txBox="1"/>
          <p:nvPr/>
        </p:nvSpPr>
        <p:spPr>
          <a:xfrm rot="18554512">
            <a:off x="8418676" y="99693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A842AA2-30E6-4C73-8F24-F746E256C2EA}"/>
              </a:ext>
            </a:extLst>
          </p:cNvPr>
          <p:cNvSpPr txBox="1"/>
          <p:nvPr/>
        </p:nvSpPr>
        <p:spPr>
          <a:xfrm rot="18554512">
            <a:off x="8829227" y="97926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B20A017-91D3-4BF8-9635-D727E5A9DD41}"/>
              </a:ext>
            </a:extLst>
          </p:cNvPr>
          <p:cNvSpPr txBox="1"/>
          <p:nvPr/>
        </p:nvSpPr>
        <p:spPr>
          <a:xfrm>
            <a:off x="712374" y="175611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E2B0BF9-2250-4CD7-9B89-131EF80F5101}"/>
              </a:ext>
            </a:extLst>
          </p:cNvPr>
          <p:cNvSpPr txBox="1"/>
          <p:nvPr/>
        </p:nvSpPr>
        <p:spPr>
          <a:xfrm>
            <a:off x="600294" y="244913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ECD1763-C6F0-46A5-884A-111466F4EAAF}"/>
              </a:ext>
            </a:extLst>
          </p:cNvPr>
          <p:cNvSpPr txBox="1"/>
          <p:nvPr/>
        </p:nvSpPr>
        <p:spPr>
          <a:xfrm>
            <a:off x="5576004" y="1794293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1F10563-A4F6-47E8-B466-A504BAFA6FF9}"/>
              </a:ext>
            </a:extLst>
          </p:cNvPr>
          <p:cNvSpPr txBox="1"/>
          <p:nvPr/>
        </p:nvSpPr>
        <p:spPr>
          <a:xfrm>
            <a:off x="5463924" y="2487317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DE564278-F3F6-4AEE-9973-11B9F6406E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59481" y="4001570"/>
            <a:ext cx="3307968" cy="724854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3112D16E-680F-4AC4-8CF8-1B30875BA2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54262" y="4888066"/>
            <a:ext cx="3279880" cy="373873"/>
          </a:xfrm>
          <a:prstGeom prst="rect">
            <a:avLst/>
          </a:prstGeom>
        </p:spPr>
      </p:pic>
      <p:sp>
        <p:nvSpPr>
          <p:cNvPr id="46" name="矩形 45">
            <a:extLst>
              <a:ext uri="{FF2B5EF4-FFF2-40B4-BE49-F238E27FC236}">
                <a16:creationId xmlns:a16="http://schemas.microsoft.com/office/drawing/2014/main" id="{FE351482-528B-4509-8B90-3DE2462B2051}"/>
              </a:ext>
            </a:extLst>
          </p:cNvPr>
          <p:cNvSpPr/>
          <p:nvPr/>
        </p:nvSpPr>
        <p:spPr>
          <a:xfrm>
            <a:off x="2121189" y="1587913"/>
            <a:ext cx="1308986" cy="143827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41C49AE2-F476-4F0C-AFC6-9B6B6DB9299E}"/>
              </a:ext>
            </a:extLst>
          </p:cNvPr>
          <p:cNvSpPr/>
          <p:nvPr/>
        </p:nvSpPr>
        <p:spPr>
          <a:xfrm>
            <a:off x="2262437" y="3901407"/>
            <a:ext cx="1308986" cy="1438276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94722A2-5D48-48AD-9DC3-BCC445AB1433}"/>
              </a:ext>
            </a:extLst>
          </p:cNvPr>
          <p:cNvSpPr txBox="1"/>
          <p:nvPr/>
        </p:nvSpPr>
        <p:spPr>
          <a:xfrm rot="18554512">
            <a:off x="2229108" y="333569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7F0E87B-A117-428A-A8A7-DDD41FD31FE4}"/>
              </a:ext>
            </a:extLst>
          </p:cNvPr>
          <p:cNvSpPr txBox="1"/>
          <p:nvPr/>
        </p:nvSpPr>
        <p:spPr>
          <a:xfrm rot="18554512">
            <a:off x="2639659" y="331802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3A52418-D288-44C5-8FA9-EE8E4428173C}"/>
              </a:ext>
            </a:extLst>
          </p:cNvPr>
          <p:cNvSpPr txBox="1"/>
          <p:nvPr/>
        </p:nvSpPr>
        <p:spPr>
          <a:xfrm rot="18554512">
            <a:off x="3050210" y="330035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5093C22-E348-495C-920C-ACAC209B10A7}"/>
              </a:ext>
            </a:extLst>
          </p:cNvPr>
          <p:cNvSpPr txBox="1"/>
          <p:nvPr/>
        </p:nvSpPr>
        <p:spPr>
          <a:xfrm>
            <a:off x="680592" y="4195042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37DA5B2B-4E9D-47FE-8414-6439CC2B02EB}"/>
              </a:ext>
            </a:extLst>
          </p:cNvPr>
          <p:cNvSpPr txBox="1"/>
          <p:nvPr/>
        </p:nvSpPr>
        <p:spPr>
          <a:xfrm>
            <a:off x="568512" y="4888066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227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FD61E35-D29A-4ADE-B51E-AB453BACA569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D195FA87-F2ED-4064-B0C1-C9CD9E567B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4318" y="1125773"/>
            <a:ext cx="3682999" cy="867833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3B0C0F1D-1E0A-423A-81B4-B6D6F00E01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2673" y="2163157"/>
            <a:ext cx="3610932" cy="450574"/>
          </a:xfrm>
          <a:prstGeom prst="rect">
            <a:avLst/>
          </a:prstGeom>
        </p:spPr>
      </p:pic>
      <p:sp>
        <p:nvSpPr>
          <p:cNvPr id="45" name="矩形 44">
            <a:extLst>
              <a:ext uri="{FF2B5EF4-FFF2-40B4-BE49-F238E27FC236}">
                <a16:creationId xmlns:a16="http://schemas.microsoft.com/office/drawing/2014/main" id="{FE81DCB8-2C0B-4F8D-9CC4-61D8319617E8}"/>
              </a:ext>
            </a:extLst>
          </p:cNvPr>
          <p:cNvSpPr/>
          <p:nvPr/>
        </p:nvSpPr>
        <p:spPr>
          <a:xfrm>
            <a:off x="2900360" y="1035783"/>
            <a:ext cx="1237879" cy="165208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75666CE-26BA-4B73-B3FC-1998305C1229}"/>
              </a:ext>
            </a:extLst>
          </p:cNvPr>
          <p:cNvSpPr txBox="1"/>
          <p:nvPr/>
        </p:nvSpPr>
        <p:spPr>
          <a:xfrm rot="18554512">
            <a:off x="2741035" y="50512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D609B54-2561-4212-A97F-49F625168459}"/>
              </a:ext>
            </a:extLst>
          </p:cNvPr>
          <p:cNvSpPr txBox="1"/>
          <p:nvPr/>
        </p:nvSpPr>
        <p:spPr>
          <a:xfrm rot="18554512">
            <a:off x="3151586" y="48745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1FDCBD1-8939-44D1-8EBD-B7B2F9DB392A}"/>
              </a:ext>
            </a:extLst>
          </p:cNvPr>
          <p:cNvSpPr txBox="1"/>
          <p:nvPr/>
        </p:nvSpPr>
        <p:spPr>
          <a:xfrm rot="18554512">
            <a:off x="3562137" y="46978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A0556884-E75E-43DF-8B2F-9A85468597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91100" y="4879070"/>
            <a:ext cx="3841373" cy="690486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B1D35AA9-0A00-4686-B917-5DCFBD952D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31855" y="5839579"/>
            <a:ext cx="3595560" cy="524199"/>
          </a:xfrm>
          <a:prstGeom prst="rect">
            <a:avLst/>
          </a:prstGeom>
        </p:spPr>
      </p:pic>
      <p:sp>
        <p:nvSpPr>
          <p:cNvPr id="55" name="矩形 54">
            <a:extLst>
              <a:ext uri="{FF2B5EF4-FFF2-40B4-BE49-F238E27FC236}">
                <a16:creationId xmlns:a16="http://schemas.microsoft.com/office/drawing/2014/main" id="{10695286-82B4-4607-8687-0C18273DB336}"/>
              </a:ext>
            </a:extLst>
          </p:cNvPr>
          <p:cNvSpPr/>
          <p:nvPr/>
        </p:nvSpPr>
        <p:spPr>
          <a:xfrm>
            <a:off x="8664591" y="4791041"/>
            <a:ext cx="1308986" cy="165208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01BBD26C-D14C-4779-94C9-CA3D6D3F042F}"/>
              </a:ext>
            </a:extLst>
          </p:cNvPr>
          <p:cNvSpPr txBox="1"/>
          <p:nvPr/>
        </p:nvSpPr>
        <p:spPr>
          <a:xfrm rot="18554512">
            <a:off x="8518590" y="431097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4D35DE9-F75E-46A0-8DD7-0F8B8D4B1892}"/>
              </a:ext>
            </a:extLst>
          </p:cNvPr>
          <p:cNvSpPr txBox="1"/>
          <p:nvPr/>
        </p:nvSpPr>
        <p:spPr>
          <a:xfrm rot="18554512">
            <a:off x="8929141" y="429330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6A20D12-7E77-4FDC-97C0-B87BA93575E2}"/>
              </a:ext>
            </a:extLst>
          </p:cNvPr>
          <p:cNvSpPr txBox="1"/>
          <p:nvPr/>
        </p:nvSpPr>
        <p:spPr>
          <a:xfrm rot="18554512">
            <a:off x="9339692" y="427563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DB8E87EC-AECC-4FDA-8DD8-9813411C0E9B}"/>
              </a:ext>
            </a:extLst>
          </p:cNvPr>
          <p:cNvSpPr txBox="1"/>
          <p:nvPr/>
        </p:nvSpPr>
        <p:spPr>
          <a:xfrm>
            <a:off x="630747" y="1396508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564A1E2F-6996-412C-B1E6-15531FFD8BB7}"/>
              </a:ext>
            </a:extLst>
          </p:cNvPr>
          <p:cNvSpPr txBox="1"/>
          <p:nvPr/>
        </p:nvSpPr>
        <p:spPr>
          <a:xfrm>
            <a:off x="518667" y="208953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8CE92713-6644-4CA6-8083-B0791C65CD9D}"/>
              </a:ext>
            </a:extLst>
          </p:cNvPr>
          <p:cNvSpPr txBox="1"/>
          <p:nvPr/>
        </p:nvSpPr>
        <p:spPr>
          <a:xfrm>
            <a:off x="6962379" y="5146555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4CC7C744-B72A-4D6E-9833-7E66DFE75FDA}"/>
              </a:ext>
            </a:extLst>
          </p:cNvPr>
          <p:cNvSpPr txBox="1"/>
          <p:nvPr/>
        </p:nvSpPr>
        <p:spPr>
          <a:xfrm>
            <a:off x="6799572" y="5845471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65" name="图片 64">
            <a:extLst>
              <a:ext uri="{FF2B5EF4-FFF2-40B4-BE49-F238E27FC236}">
                <a16:creationId xmlns:a16="http://schemas.microsoft.com/office/drawing/2014/main" id="{88ECE644-8388-454B-B796-4C678E0730E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0678" b="20988"/>
          <a:stretch/>
        </p:blipFill>
        <p:spPr>
          <a:xfrm>
            <a:off x="1298156" y="3180176"/>
            <a:ext cx="5287894" cy="626017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8C347942-DF76-4DCF-A124-016C3BC6402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35320"/>
          <a:stretch/>
        </p:blipFill>
        <p:spPr>
          <a:xfrm>
            <a:off x="1414229" y="3938154"/>
            <a:ext cx="5370957" cy="570522"/>
          </a:xfrm>
          <a:prstGeom prst="rect">
            <a:avLst/>
          </a:prstGeom>
        </p:spPr>
      </p:pic>
      <p:sp>
        <p:nvSpPr>
          <p:cNvPr id="67" name="矩形 66">
            <a:extLst>
              <a:ext uri="{FF2B5EF4-FFF2-40B4-BE49-F238E27FC236}">
                <a16:creationId xmlns:a16="http://schemas.microsoft.com/office/drawing/2014/main" id="{B9206864-3192-40EF-BDB1-2DEB9663E8CC}"/>
              </a:ext>
            </a:extLst>
          </p:cNvPr>
          <p:cNvSpPr/>
          <p:nvPr/>
        </p:nvSpPr>
        <p:spPr>
          <a:xfrm>
            <a:off x="2067278" y="3076295"/>
            <a:ext cx="1232771" cy="165208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CB5B59E7-9534-4D1B-9C64-80ACFEE5A779}"/>
              </a:ext>
            </a:extLst>
          </p:cNvPr>
          <p:cNvSpPr txBox="1"/>
          <p:nvPr/>
        </p:nvSpPr>
        <p:spPr>
          <a:xfrm>
            <a:off x="434585" y="3281374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4C67B69-06A9-4B6E-A90F-9910952D2841}"/>
              </a:ext>
            </a:extLst>
          </p:cNvPr>
          <p:cNvSpPr txBox="1"/>
          <p:nvPr/>
        </p:nvSpPr>
        <p:spPr>
          <a:xfrm>
            <a:off x="322505" y="3974398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71" name="图片 70">
            <a:extLst>
              <a:ext uri="{FF2B5EF4-FFF2-40B4-BE49-F238E27FC236}">
                <a16:creationId xmlns:a16="http://schemas.microsoft.com/office/drawing/2014/main" id="{0A03C3B7-0716-424B-BE62-32EBB86E0A6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25623"/>
          <a:stretch/>
        </p:blipFill>
        <p:spPr>
          <a:xfrm>
            <a:off x="6522217" y="1088406"/>
            <a:ext cx="3594637" cy="630692"/>
          </a:xfrm>
          <a:prstGeom prst="rect">
            <a:avLst/>
          </a:prstGeom>
        </p:spPr>
      </p:pic>
      <p:pic>
        <p:nvPicPr>
          <p:cNvPr id="72" name="图片 71">
            <a:extLst>
              <a:ext uri="{FF2B5EF4-FFF2-40B4-BE49-F238E27FC236}">
                <a16:creationId xmlns:a16="http://schemas.microsoft.com/office/drawing/2014/main" id="{49ADBB8E-80C1-4936-B423-5B4798CBB31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01603" y="1867338"/>
            <a:ext cx="2886070" cy="361524"/>
          </a:xfrm>
          <a:prstGeom prst="rect">
            <a:avLst/>
          </a:prstGeom>
        </p:spPr>
      </p:pic>
      <p:sp>
        <p:nvSpPr>
          <p:cNvPr id="73" name="矩形 72">
            <a:extLst>
              <a:ext uri="{FF2B5EF4-FFF2-40B4-BE49-F238E27FC236}">
                <a16:creationId xmlns:a16="http://schemas.microsoft.com/office/drawing/2014/main" id="{86153050-4202-43E1-948B-60E618DB197A}"/>
              </a:ext>
            </a:extLst>
          </p:cNvPr>
          <p:cNvSpPr/>
          <p:nvPr/>
        </p:nvSpPr>
        <p:spPr>
          <a:xfrm>
            <a:off x="6658199" y="973390"/>
            <a:ext cx="1308986" cy="15620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4" name="矩形 73">
            <a:extLst>
              <a:ext uri="{FF2B5EF4-FFF2-40B4-BE49-F238E27FC236}">
                <a16:creationId xmlns:a16="http://schemas.microsoft.com/office/drawing/2014/main" id="{9D14FC2D-4BDB-4E8A-969B-17C7A630F220}"/>
              </a:ext>
            </a:extLst>
          </p:cNvPr>
          <p:cNvSpPr/>
          <p:nvPr/>
        </p:nvSpPr>
        <p:spPr>
          <a:xfrm>
            <a:off x="7967185" y="973390"/>
            <a:ext cx="1227326" cy="15620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76F4D16-C3B1-4CF0-AC58-D84818C8C027}"/>
              </a:ext>
            </a:extLst>
          </p:cNvPr>
          <p:cNvSpPr txBox="1"/>
          <p:nvPr/>
        </p:nvSpPr>
        <p:spPr>
          <a:xfrm rot="18554512">
            <a:off x="6749476" y="43103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0BB3C95-365E-46B2-9265-1CCBF947D197}"/>
              </a:ext>
            </a:extLst>
          </p:cNvPr>
          <p:cNvSpPr txBox="1"/>
          <p:nvPr/>
        </p:nvSpPr>
        <p:spPr>
          <a:xfrm rot="18554512">
            <a:off x="7160027" y="41336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F804E01-5EE3-4DFE-A1C7-5D66EA316204}"/>
              </a:ext>
            </a:extLst>
          </p:cNvPr>
          <p:cNvSpPr txBox="1"/>
          <p:nvPr/>
        </p:nvSpPr>
        <p:spPr>
          <a:xfrm rot="18554512">
            <a:off x="7570578" y="39569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F2E7F256-527D-43BB-A7BE-8CF9DF70F48A}"/>
              </a:ext>
            </a:extLst>
          </p:cNvPr>
          <p:cNvSpPr txBox="1"/>
          <p:nvPr/>
        </p:nvSpPr>
        <p:spPr>
          <a:xfrm rot="18554512">
            <a:off x="7964491" y="43926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FE85A130-F932-4DC4-8B35-641CE2D2B316}"/>
              </a:ext>
            </a:extLst>
          </p:cNvPr>
          <p:cNvSpPr txBox="1"/>
          <p:nvPr/>
        </p:nvSpPr>
        <p:spPr>
          <a:xfrm rot="18554512">
            <a:off x="8375042" y="42158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071FDB80-7158-4DA6-B968-525F01966948}"/>
              </a:ext>
            </a:extLst>
          </p:cNvPr>
          <p:cNvSpPr txBox="1"/>
          <p:nvPr/>
        </p:nvSpPr>
        <p:spPr>
          <a:xfrm rot="18554512">
            <a:off x="8785593" y="40391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9" name="图片 88">
            <a:extLst>
              <a:ext uri="{FF2B5EF4-FFF2-40B4-BE49-F238E27FC236}">
                <a16:creationId xmlns:a16="http://schemas.microsoft.com/office/drawing/2014/main" id="{9AB82197-A2B9-4D6A-B5F7-D7872A5D176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9211" b="17336"/>
          <a:stretch/>
        </p:blipFill>
        <p:spPr>
          <a:xfrm>
            <a:off x="1503510" y="4999553"/>
            <a:ext cx="4983094" cy="590551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34E32F4E-2DD6-4B6B-ABE8-D5985178E3E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268928" y="5777187"/>
            <a:ext cx="5374012" cy="590550"/>
          </a:xfrm>
          <a:prstGeom prst="rect">
            <a:avLst/>
          </a:prstGeom>
        </p:spPr>
      </p:pic>
      <p:sp>
        <p:nvSpPr>
          <p:cNvPr id="91" name="矩形 90">
            <a:extLst>
              <a:ext uri="{FF2B5EF4-FFF2-40B4-BE49-F238E27FC236}">
                <a16:creationId xmlns:a16="http://schemas.microsoft.com/office/drawing/2014/main" id="{6080F90B-BB5A-4935-ACC1-5408D17A482B}"/>
              </a:ext>
            </a:extLst>
          </p:cNvPr>
          <p:cNvSpPr/>
          <p:nvPr/>
        </p:nvSpPr>
        <p:spPr>
          <a:xfrm>
            <a:off x="2103187" y="4922525"/>
            <a:ext cx="1104900" cy="162718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0B2E9132-3502-47C0-BB5D-9771EAE4B697}"/>
              </a:ext>
            </a:extLst>
          </p:cNvPr>
          <p:cNvSpPr txBox="1"/>
          <p:nvPr/>
        </p:nvSpPr>
        <p:spPr>
          <a:xfrm>
            <a:off x="364722" y="5141007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52F3AA81-79F6-4DC6-A6A7-FEC38D5EA4CF}"/>
              </a:ext>
            </a:extLst>
          </p:cNvPr>
          <p:cNvSpPr txBox="1"/>
          <p:nvPr/>
        </p:nvSpPr>
        <p:spPr>
          <a:xfrm>
            <a:off x="252642" y="5834031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74955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7283270-E08D-4FE9-82E3-6F0D9814C264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AF65F247-6C10-460A-A520-8C55EC4315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3388" r="7065"/>
          <a:stretch/>
        </p:blipFill>
        <p:spPr>
          <a:xfrm>
            <a:off x="1104556" y="1244382"/>
            <a:ext cx="4935747" cy="59304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D25450F-DD9B-4A8F-92FE-5A57DD8192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4555" y="1931895"/>
            <a:ext cx="4935747" cy="414188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0BBCF1F4-A39F-4568-8868-3B9598DA994A}"/>
              </a:ext>
            </a:extLst>
          </p:cNvPr>
          <p:cNvSpPr txBox="1"/>
          <p:nvPr/>
        </p:nvSpPr>
        <p:spPr>
          <a:xfrm>
            <a:off x="240986" y="1201848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8EABC96-B5CE-47D2-8BD4-9683C9F45F6F}"/>
              </a:ext>
            </a:extLst>
          </p:cNvPr>
          <p:cNvSpPr txBox="1"/>
          <p:nvPr/>
        </p:nvSpPr>
        <p:spPr>
          <a:xfrm>
            <a:off x="128906" y="1769657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52C60EAB-3DD2-4959-A4F3-43559173C1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73" t="-7071"/>
          <a:stretch/>
        </p:blipFill>
        <p:spPr>
          <a:xfrm>
            <a:off x="7041135" y="1183904"/>
            <a:ext cx="5013960" cy="554518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C10CCF15-CCC7-4203-98EA-BDF7909FB4A5}"/>
              </a:ext>
            </a:extLst>
          </p:cNvPr>
          <p:cNvSpPr txBox="1"/>
          <p:nvPr/>
        </p:nvSpPr>
        <p:spPr>
          <a:xfrm>
            <a:off x="6301269" y="1260956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5FEFC290-F1D2-4F93-B939-0DE714C2C7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57427" y="1805108"/>
            <a:ext cx="4780483" cy="639642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3E3B3EE-3253-4AB5-BADB-23CEF1D76A4E}"/>
              </a:ext>
            </a:extLst>
          </p:cNvPr>
          <p:cNvSpPr txBox="1"/>
          <p:nvPr/>
        </p:nvSpPr>
        <p:spPr>
          <a:xfrm>
            <a:off x="6281776" y="191212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408CD175-90D4-4347-AFEB-05B13E0228A9}"/>
              </a:ext>
            </a:extLst>
          </p:cNvPr>
          <p:cNvSpPr/>
          <p:nvPr/>
        </p:nvSpPr>
        <p:spPr>
          <a:xfrm>
            <a:off x="7449054" y="1141370"/>
            <a:ext cx="1117600" cy="135733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3F6481D-471C-460F-A3D1-2648F4CA1152}"/>
              </a:ext>
            </a:extLst>
          </p:cNvPr>
          <p:cNvSpPr txBox="1"/>
          <p:nvPr/>
        </p:nvSpPr>
        <p:spPr>
          <a:xfrm rot="18554512">
            <a:off x="7254733" y="60405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6E217D15-13E2-4A35-8D4A-8DF42E7D65BF}"/>
              </a:ext>
            </a:extLst>
          </p:cNvPr>
          <p:cNvSpPr txBox="1"/>
          <p:nvPr/>
        </p:nvSpPr>
        <p:spPr>
          <a:xfrm rot="18554512">
            <a:off x="7665284" y="58638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38E74FA-D1B2-4D65-AC28-4422B8F25952}"/>
              </a:ext>
            </a:extLst>
          </p:cNvPr>
          <p:cNvSpPr txBox="1"/>
          <p:nvPr/>
        </p:nvSpPr>
        <p:spPr>
          <a:xfrm rot="18554512">
            <a:off x="8075835" y="56871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C9EEEF0-6633-4AB7-82A1-9B01492E6DB4}"/>
              </a:ext>
            </a:extLst>
          </p:cNvPr>
          <p:cNvSpPr txBox="1"/>
          <p:nvPr/>
        </p:nvSpPr>
        <p:spPr>
          <a:xfrm rot="18554512">
            <a:off x="1613316" y="60405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3A4DAF0-9ED5-4013-AA71-E962227D68DA}"/>
              </a:ext>
            </a:extLst>
          </p:cNvPr>
          <p:cNvSpPr txBox="1"/>
          <p:nvPr/>
        </p:nvSpPr>
        <p:spPr>
          <a:xfrm rot="18554512">
            <a:off x="2023867" y="58638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4E360B9-579E-4D7B-B2B7-476A4A669DD2}"/>
              </a:ext>
            </a:extLst>
          </p:cNvPr>
          <p:cNvSpPr txBox="1"/>
          <p:nvPr/>
        </p:nvSpPr>
        <p:spPr>
          <a:xfrm rot="18554512">
            <a:off x="2434418" y="56871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08355690-3621-469C-9B68-A56BDE847458}"/>
              </a:ext>
            </a:extLst>
          </p:cNvPr>
          <p:cNvSpPr/>
          <p:nvPr/>
        </p:nvSpPr>
        <p:spPr>
          <a:xfrm>
            <a:off x="1731177" y="1141370"/>
            <a:ext cx="1117600" cy="135733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CD1363B5-EB67-496E-8F44-2208C3CDD0F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28405" y="3491899"/>
            <a:ext cx="3106271" cy="598895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0EF144EA-FFD6-401C-A49E-394C108BD578}"/>
              </a:ext>
            </a:extLst>
          </p:cNvPr>
          <p:cNvSpPr txBox="1"/>
          <p:nvPr/>
        </p:nvSpPr>
        <p:spPr>
          <a:xfrm>
            <a:off x="494986" y="364466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E217360D-4BC9-439E-8CE4-02128DCF9B25}"/>
              </a:ext>
            </a:extLst>
          </p:cNvPr>
          <p:cNvSpPr txBox="1"/>
          <p:nvPr/>
        </p:nvSpPr>
        <p:spPr>
          <a:xfrm>
            <a:off x="382906" y="4212470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465A8A99-E428-4C87-B637-4E2D9D18274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16246" y="4212470"/>
            <a:ext cx="3018430" cy="598895"/>
          </a:xfrm>
          <a:prstGeom prst="rect">
            <a:avLst/>
          </a:prstGeom>
        </p:spPr>
      </p:pic>
      <p:sp>
        <p:nvSpPr>
          <p:cNvPr id="45" name="矩形 44">
            <a:extLst>
              <a:ext uri="{FF2B5EF4-FFF2-40B4-BE49-F238E27FC236}">
                <a16:creationId xmlns:a16="http://schemas.microsoft.com/office/drawing/2014/main" id="{B787E8EC-96A4-4E4D-9C72-A0DE2A08E721}"/>
              </a:ext>
            </a:extLst>
          </p:cNvPr>
          <p:cNvSpPr/>
          <p:nvPr/>
        </p:nvSpPr>
        <p:spPr>
          <a:xfrm>
            <a:off x="2239177" y="3428626"/>
            <a:ext cx="1117600" cy="146528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6729A919-9441-43B2-97A4-686285B3ED1F}"/>
              </a:ext>
            </a:extLst>
          </p:cNvPr>
          <p:cNvSpPr/>
          <p:nvPr/>
        </p:nvSpPr>
        <p:spPr>
          <a:xfrm>
            <a:off x="3356777" y="3428625"/>
            <a:ext cx="1117600" cy="146528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8D5DF3D-2F1D-45EE-A9A8-E6809E28D74B}"/>
              </a:ext>
            </a:extLst>
          </p:cNvPr>
          <p:cNvSpPr txBox="1"/>
          <p:nvPr/>
        </p:nvSpPr>
        <p:spPr>
          <a:xfrm rot="18554512">
            <a:off x="2178465" y="283394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471AA66-8FA0-4858-BE64-1B49F21E410B}"/>
              </a:ext>
            </a:extLst>
          </p:cNvPr>
          <p:cNvSpPr txBox="1"/>
          <p:nvPr/>
        </p:nvSpPr>
        <p:spPr>
          <a:xfrm rot="18554512">
            <a:off x="2589016" y="281627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84964D8F-C6B6-4F01-95A2-450B0CC47014}"/>
              </a:ext>
            </a:extLst>
          </p:cNvPr>
          <p:cNvSpPr txBox="1"/>
          <p:nvPr/>
        </p:nvSpPr>
        <p:spPr>
          <a:xfrm rot="18554512">
            <a:off x="2999567" y="279860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88AFD7F-338A-482B-8627-17D433CBA3E3}"/>
              </a:ext>
            </a:extLst>
          </p:cNvPr>
          <p:cNvSpPr txBox="1"/>
          <p:nvPr/>
        </p:nvSpPr>
        <p:spPr>
          <a:xfrm rot="18554512">
            <a:off x="3332855" y="287989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6F034F8F-C87B-4AAF-A2B8-FA1923B1954F}"/>
              </a:ext>
            </a:extLst>
          </p:cNvPr>
          <p:cNvSpPr txBox="1"/>
          <p:nvPr/>
        </p:nvSpPr>
        <p:spPr>
          <a:xfrm rot="18554512">
            <a:off x="3743406" y="286222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A1E2663-3814-440A-9850-83D7D378F2AA}"/>
              </a:ext>
            </a:extLst>
          </p:cNvPr>
          <p:cNvSpPr txBox="1"/>
          <p:nvPr/>
        </p:nvSpPr>
        <p:spPr>
          <a:xfrm rot="18554512">
            <a:off x="4153957" y="284454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0" name="图片 59">
            <a:extLst>
              <a:ext uri="{FF2B5EF4-FFF2-40B4-BE49-F238E27FC236}">
                <a16:creationId xmlns:a16="http://schemas.microsoft.com/office/drawing/2014/main" id="{E36DC768-6FA0-4F2B-8692-F328BD006DD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567440" y="3613805"/>
            <a:ext cx="3301937" cy="639642"/>
          </a:xfrm>
          <a:prstGeom prst="rect">
            <a:avLst/>
          </a:prstGeom>
        </p:spPr>
      </p:pic>
      <p:sp>
        <p:nvSpPr>
          <p:cNvPr id="61" name="文本框 60">
            <a:extLst>
              <a:ext uri="{FF2B5EF4-FFF2-40B4-BE49-F238E27FC236}">
                <a16:creationId xmlns:a16="http://schemas.microsoft.com/office/drawing/2014/main" id="{CD0C18B3-AB4B-4379-8FE3-791FD85B52AF}"/>
              </a:ext>
            </a:extLst>
          </p:cNvPr>
          <p:cNvSpPr txBox="1"/>
          <p:nvPr/>
        </p:nvSpPr>
        <p:spPr>
          <a:xfrm>
            <a:off x="5652276" y="3721462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1CDCB4CB-46B3-47C9-A085-806B03EE0353}"/>
              </a:ext>
            </a:extLst>
          </p:cNvPr>
          <p:cNvSpPr txBox="1"/>
          <p:nvPr/>
        </p:nvSpPr>
        <p:spPr>
          <a:xfrm>
            <a:off x="5540196" y="4289271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66" name="图片 65">
            <a:extLst>
              <a:ext uri="{FF2B5EF4-FFF2-40B4-BE49-F238E27FC236}">
                <a16:creationId xmlns:a16="http://schemas.microsoft.com/office/drawing/2014/main" id="{AD7A2DC5-B103-44CB-AF85-B4DA5DFE7EF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67440" y="4307406"/>
            <a:ext cx="3472117" cy="586506"/>
          </a:xfrm>
          <a:prstGeom prst="rect">
            <a:avLst/>
          </a:prstGeom>
        </p:spPr>
      </p:pic>
      <p:sp>
        <p:nvSpPr>
          <p:cNvPr id="67" name="矩形 66">
            <a:extLst>
              <a:ext uri="{FF2B5EF4-FFF2-40B4-BE49-F238E27FC236}">
                <a16:creationId xmlns:a16="http://schemas.microsoft.com/office/drawing/2014/main" id="{C71DAD4D-D1BA-443E-9425-070DF8B11353}"/>
              </a:ext>
            </a:extLst>
          </p:cNvPr>
          <p:cNvSpPr/>
          <p:nvPr/>
        </p:nvSpPr>
        <p:spPr>
          <a:xfrm>
            <a:off x="6698627" y="3556627"/>
            <a:ext cx="1117600" cy="146528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矩形 67">
            <a:extLst>
              <a:ext uri="{FF2B5EF4-FFF2-40B4-BE49-F238E27FC236}">
                <a16:creationId xmlns:a16="http://schemas.microsoft.com/office/drawing/2014/main" id="{E7F4083E-1845-4608-9EF7-71AB77A00E6D}"/>
              </a:ext>
            </a:extLst>
          </p:cNvPr>
          <p:cNvSpPr/>
          <p:nvPr/>
        </p:nvSpPr>
        <p:spPr>
          <a:xfrm>
            <a:off x="7803897" y="3525089"/>
            <a:ext cx="1117600" cy="146528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A6A25A5D-E9E1-48EA-9DA3-DAB3C55B79FC}"/>
              </a:ext>
            </a:extLst>
          </p:cNvPr>
          <p:cNvSpPr txBox="1"/>
          <p:nvPr/>
        </p:nvSpPr>
        <p:spPr>
          <a:xfrm rot="18554512">
            <a:off x="6433631" y="291822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2AC3ED84-A3EE-4F61-99EC-121D799CBC18}"/>
              </a:ext>
            </a:extLst>
          </p:cNvPr>
          <p:cNvSpPr txBox="1"/>
          <p:nvPr/>
        </p:nvSpPr>
        <p:spPr>
          <a:xfrm rot="18554512">
            <a:off x="6844182" y="290055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CBA7EB5-CDA7-4827-81BC-07E9FAC90AA4}"/>
              </a:ext>
            </a:extLst>
          </p:cNvPr>
          <p:cNvSpPr txBox="1"/>
          <p:nvPr/>
        </p:nvSpPr>
        <p:spPr>
          <a:xfrm rot="18554512">
            <a:off x="7254733" y="288288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6A71ED4D-D34B-48BC-A5BA-BD5299BA1BD4}"/>
              </a:ext>
            </a:extLst>
          </p:cNvPr>
          <p:cNvSpPr txBox="1"/>
          <p:nvPr/>
        </p:nvSpPr>
        <p:spPr>
          <a:xfrm rot="18554512">
            <a:off x="7703789" y="291222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6C227DAE-36BD-4EFE-8B79-9FE742452105}"/>
              </a:ext>
            </a:extLst>
          </p:cNvPr>
          <p:cNvSpPr txBox="1"/>
          <p:nvPr/>
        </p:nvSpPr>
        <p:spPr>
          <a:xfrm rot="18554512">
            <a:off x="8114340" y="289455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FE211505-956A-4F15-96E0-D0D4739A8733}"/>
              </a:ext>
            </a:extLst>
          </p:cNvPr>
          <p:cNvSpPr txBox="1"/>
          <p:nvPr/>
        </p:nvSpPr>
        <p:spPr>
          <a:xfrm rot="18554512">
            <a:off x="8524891" y="287687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95039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8F11AED-BB9F-470C-9350-A1758C7AEAF4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683AFD4-4701-4B57-AEC7-86DC3C281A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5299" y="1564282"/>
            <a:ext cx="3421652" cy="8064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FED93239-5F5A-404F-B0FF-472062CA67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6153"/>
          <a:stretch/>
        </p:blipFill>
        <p:spPr>
          <a:xfrm>
            <a:off x="1373953" y="2481381"/>
            <a:ext cx="3310306" cy="59055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E84DE00F-F06E-4DBC-9B07-FBF58B866BFA}"/>
              </a:ext>
            </a:extLst>
          </p:cNvPr>
          <p:cNvSpPr/>
          <p:nvPr/>
        </p:nvSpPr>
        <p:spPr>
          <a:xfrm>
            <a:off x="1590775" y="1546343"/>
            <a:ext cx="1308986" cy="162718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90B7849-C13B-4549-84A4-D10B078A12AD}"/>
              </a:ext>
            </a:extLst>
          </p:cNvPr>
          <p:cNvSpPr txBox="1"/>
          <p:nvPr/>
        </p:nvSpPr>
        <p:spPr>
          <a:xfrm rot="18554512">
            <a:off x="1588081" y="86881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5886593-9590-4EB1-9ED3-94EFB91311EF}"/>
              </a:ext>
            </a:extLst>
          </p:cNvPr>
          <p:cNvSpPr txBox="1"/>
          <p:nvPr/>
        </p:nvSpPr>
        <p:spPr>
          <a:xfrm rot="18554512">
            <a:off x="1998632" y="85113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38696A2-8459-4D86-BB94-5691CE7EBA4C}"/>
              </a:ext>
            </a:extLst>
          </p:cNvPr>
          <p:cNvSpPr txBox="1"/>
          <p:nvPr/>
        </p:nvSpPr>
        <p:spPr>
          <a:xfrm rot="18554512">
            <a:off x="2409183" y="83346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D890307E-F6CF-4343-8045-28A9D1B6C7B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7523"/>
          <a:stretch/>
        </p:blipFill>
        <p:spPr>
          <a:xfrm>
            <a:off x="6515100" y="1509327"/>
            <a:ext cx="3968750" cy="831090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7A213EB8-6F73-42AA-B138-622036E4E5B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46260" y="2423031"/>
            <a:ext cx="3608990" cy="590946"/>
          </a:xfrm>
          <a:prstGeom prst="rect">
            <a:avLst/>
          </a:prstGeom>
        </p:spPr>
      </p:pic>
      <p:sp>
        <p:nvSpPr>
          <p:cNvPr id="23" name="矩形 22">
            <a:extLst>
              <a:ext uri="{FF2B5EF4-FFF2-40B4-BE49-F238E27FC236}">
                <a16:creationId xmlns:a16="http://schemas.microsoft.com/office/drawing/2014/main" id="{5EB04423-8351-43D2-8AF1-5224E99B6E0B}"/>
              </a:ext>
            </a:extLst>
          </p:cNvPr>
          <p:cNvSpPr/>
          <p:nvPr/>
        </p:nvSpPr>
        <p:spPr>
          <a:xfrm>
            <a:off x="7401625" y="1459855"/>
            <a:ext cx="1308986" cy="162718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EB2378EE-FEE7-43E3-8BE8-0EA55205356A}"/>
              </a:ext>
            </a:extLst>
          </p:cNvPr>
          <p:cNvSpPr/>
          <p:nvPr/>
        </p:nvSpPr>
        <p:spPr>
          <a:xfrm>
            <a:off x="8710610" y="1448121"/>
            <a:ext cx="1443039" cy="162718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87C802F-E904-4EA4-898A-4D1104DFA564}"/>
              </a:ext>
            </a:extLst>
          </p:cNvPr>
          <p:cNvSpPr txBox="1"/>
          <p:nvPr/>
        </p:nvSpPr>
        <p:spPr>
          <a:xfrm rot="18554512">
            <a:off x="7398930" y="82995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02654D2-CED2-4CE7-A835-B0D2E2BC1848}"/>
              </a:ext>
            </a:extLst>
          </p:cNvPr>
          <p:cNvSpPr txBox="1"/>
          <p:nvPr/>
        </p:nvSpPr>
        <p:spPr>
          <a:xfrm rot="18554512">
            <a:off x="7809481" y="81228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AE90929-025C-43E0-8F53-23B9E3714A7A}"/>
              </a:ext>
            </a:extLst>
          </p:cNvPr>
          <p:cNvSpPr txBox="1"/>
          <p:nvPr/>
        </p:nvSpPr>
        <p:spPr>
          <a:xfrm rot="18554512">
            <a:off x="8220032" y="79461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BBBDB30-3555-41EE-A28A-737A65BC16F5}"/>
              </a:ext>
            </a:extLst>
          </p:cNvPr>
          <p:cNvSpPr txBox="1"/>
          <p:nvPr/>
        </p:nvSpPr>
        <p:spPr>
          <a:xfrm rot="18554512">
            <a:off x="8783230" y="81583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99F495F-9437-4F0C-B2DB-BD7B414E4347}"/>
              </a:ext>
            </a:extLst>
          </p:cNvPr>
          <p:cNvSpPr txBox="1"/>
          <p:nvPr/>
        </p:nvSpPr>
        <p:spPr>
          <a:xfrm rot="18554512">
            <a:off x="9193781" y="79816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EE47E49-89D7-44C4-B115-E2D7EAACBED5}"/>
              </a:ext>
            </a:extLst>
          </p:cNvPr>
          <p:cNvSpPr txBox="1"/>
          <p:nvPr/>
        </p:nvSpPr>
        <p:spPr>
          <a:xfrm rot="18554512">
            <a:off x="9604332" y="78049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2274902-3968-4FCF-B6BF-1EA33B446920}"/>
              </a:ext>
            </a:extLst>
          </p:cNvPr>
          <p:cNvSpPr txBox="1"/>
          <p:nvPr/>
        </p:nvSpPr>
        <p:spPr>
          <a:xfrm>
            <a:off x="249335" y="178151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71AF2BF-4A40-4095-A72D-301A5DE2F676}"/>
              </a:ext>
            </a:extLst>
          </p:cNvPr>
          <p:cNvSpPr txBox="1"/>
          <p:nvPr/>
        </p:nvSpPr>
        <p:spPr>
          <a:xfrm>
            <a:off x="137255" y="247453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3622FDCE-5B99-4D38-9007-918F3CAB873B}"/>
              </a:ext>
            </a:extLst>
          </p:cNvPr>
          <p:cNvSpPr txBox="1"/>
          <p:nvPr/>
        </p:nvSpPr>
        <p:spPr>
          <a:xfrm>
            <a:off x="5545417" y="178151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2DB4B80-620F-4EC1-A6A4-E8E405A2D8EC}"/>
              </a:ext>
            </a:extLst>
          </p:cNvPr>
          <p:cNvSpPr txBox="1"/>
          <p:nvPr/>
        </p:nvSpPr>
        <p:spPr>
          <a:xfrm>
            <a:off x="5433337" y="247453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56" name="图片 55">
            <a:extLst>
              <a:ext uri="{FF2B5EF4-FFF2-40B4-BE49-F238E27FC236}">
                <a16:creationId xmlns:a16="http://schemas.microsoft.com/office/drawing/2014/main" id="{4042B2D2-702C-4889-8441-12C5302272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73504" y="4992802"/>
            <a:ext cx="5372756" cy="451046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B208CB9B-E516-4DA7-BD7F-9D243376EE3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10598" y="4337764"/>
            <a:ext cx="5298568" cy="609570"/>
          </a:xfrm>
          <a:prstGeom prst="rect">
            <a:avLst/>
          </a:prstGeom>
        </p:spPr>
      </p:pic>
      <p:sp>
        <p:nvSpPr>
          <p:cNvPr id="59" name="矩形 58">
            <a:extLst>
              <a:ext uri="{FF2B5EF4-FFF2-40B4-BE49-F238E27FC236}">
                <a16:creationId xmlns:a16="http://schemas.microsoft.com/office/drawing/2014/main" id="{1C8453E6-ADA2-420C-B77F-50F2F064F8BD}"/>
              </a:ext>
            </a:extLst>
          </p:cNvPr>
          <p:cNvSpPr/>
          <p:nvPr/>
        </p:nvSpPr>
        <p:spPr>
          <a:xfrm>
            <a:off x="3082440" y="4158944"/>
            <a:ext cx="1234376" cy="1550744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C364058-DC1C-48D5-BDDB-E3EF4DB329C7}"/>
              </a:ext>
            </a:extLst>
          </p:cNvPr>
          <p:cNvSpPr txBox="1"/>
          <p:nvPr/>
        </p:nvSpPr>
        <p:spPr>
          <a:xfrm rot="18554512">
            <a:off x="3022977" y="358563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0F784627-C995-4C67-A12D-DF46AE8DB1E3}"/>
              </a:ext>
            </a:extLst>
          </p:cNvPr>
          <p:cNvSpPr txBox="1"/>
          <p:nvPr/>
        </p:nvSpPr>
        <p:spPr>
          <a:xfrm rot="18554512">
            <a:off x="3433528" y="356796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D9CE5F52-F662-4A2E-A1C6-ED442047562F}"/>
              </a:ext>
            </a:extLst>
          </p:cNvPr>
          <p:cNvSpPr txBox="1"/>
          <p:nvPr/>
        </p:nvSpPr>
        <p:spPr>
          <a:xfrm rot="18554512">
            <a:off x="3793789" y="355913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54C61FA9-3513-4579-AB3D-C45E79CF1CCD}"/>
              </a:ext>
            </a:extLst>
          </p:cNvPr>
          <p:cNvSpPr txBox="1"/>
          <p:nvPr/>
        </p:nvSpPr>
        <p:spPr>
          <a:xfrm>
            <a:off x="332650" y="4397788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8C662F7-0507-4ED2-8A62-C668CB2C079C}"/>
              </a:ext>
            </a:extLst>
          </p:cNvPr>
          <p:cNvSpPr txBox="1"/>
          <p:nvPr/>
        </p:nvSpPr>
        <p:spPr>
          <a:xfrm>
            <a:off x="220570" y="509081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792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>
            <a:extLst>
              <a:ext uri="{FF2B5EF4-FFF2-40B4-BE49-F238E27FC236}">
                <a16:creationId xmlns:a16="http://schemas.microsoft.com/office/drawing/2014/main" id="{468C9155-E284-4E05-B32E-42DED0A47F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86793" y="2035172"/>
            <a:ext cx="3254116" cy="55974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F5EC015-3EAE-4E0A-BAF6-E93A6B99C2FE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FDE41AC-4DA8-48BE-A96B-BEBBA30F9DC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20678" b="20988"/>
          <a:stretch/>
        </p:blipFill>
        <p:spPr>
          <a:xfrm>
            <a:off x="1237477" y="1263704"/>
            <a:ext cx="4699773" cy="556391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29AAA2B-7B43-428B-AEED-55A8D86BE76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35320"/>
          <a:stretch/>
        </p:blipFill>
        <p:spPr>
          <a:xfrm>
            <a:off x="1237477" y="1937611"/>
            <a:ext cx="4947423" cy="525533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CEAF6559-D6A9-4E69-995E-B57CA41E2BD3}"/>
              </a:ext>
            </a:extLst>
          </p:cNvPr>
          <p:cNvSpPr/>
          <p:nvPr/>
        </p:nvSpPr>
        <p:spPr>
          <a:xfrm>
            <a:off x="2978149" y="1174750"/>
            <a:ext cx="1047751" cy="152831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EFE1E37-8591-4678-912E-AA32BD77E6E4}"/>
              </a:ext>
            </a:extLst>
          </p:cNvPr>
          <p:cNvSpPr txBox="1"/>
          <p:nvPr/>
        </p:nvSpPr>
        <p:spPr>
          <a:xfrm>
            <a:off x="373906" y="1364902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92E12ED-DBB7-41D4-AA85-83DB5BDF83F7}"/>
              </a:ext>
            </a:extLst>
          </p:cNvPr>
          <p:cNvSpPr txBox="1"/>
          <p:nvPr/>
        </p:nvSpPr>
        <p:spPr>
          <a:xfrm>
            <a:off x="261826" y="2057926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F4BFDFE-C234-4760-BD0A-741CF4E66AF6}"/>
              </a:ext>
            </a:extLst>
          </p:cNvPr>
          <p:cNvSpPr txBox="1"/>
          <p:nvPr/>
        </p:nvSpPr>
        <p:spPr>
          <a:xfrm rot="18554512">
            <a:off x="2808193" y="60144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7DA6547-910D-4B19-B0AB-5332C7835537}"/>
              </a:ext>
            </a:extLst>
          </p:cNvPr>
          <p:cNvSpPr txBox="1"/>
          <p:nvPr/>
        </p:nvSpPr>
        <p:spPr>
          <a:xfrm rot="18554512">
            <a:off x="3218744" y="58377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8AF6CBAA-4109-4057-9EAB-841D08BE12E6}"/>
              </a:ext>
            </a:extLst>
          </p:cNvPr>
          <p:cNvSpPr txBox="1"/>
          <p:nvPr/>
        </p:nvSpPr>
        <p:spPr>
          <a:xfrm rot="18554512">
            <a:off x="3629295" y="56610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1EF21FD7-F415-470D-9001-8C8E5EAF2E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47752" y="1174750"/>
            <a:ext cx="3406771" cy="844952"/>
          </a:xfrm>
          <a:prstGeom prst="rect">
            <a:avLst/>
          </a:prstGeom>
        </p:spPr>
      </p:pic>
      <p:sp>
        <p:nvSpPr>
          <p:cNvPr id="19" name="矩形 18">
            <a:extLst>
              <a:ext uri="{FF2B5EF4-FFF2-40B4-BE49-F238E27FC236}">
                <a16:creationId xmlns:a16="http://schemas.microsoft.com/office/drawing/2014/main" id="{1F4A1CDD-EEEB-4CE7-AD59-0C12F5A47EE6}"/>
              </a:ext>
            </a:extLst>
          </p:cNvPr>
          <p:cNvSpPr/>
          <p:nvPr/>
        </p:nvSpPr>
        <p:spPr>
          <a:xfrm>
            <a:off x="8205490" y="1102432"/>
            <a:ext cx="1308986" cy="15620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E9E0C17F-A924-4169-8982-6AEB205D82EF}"/>
              </a:ext>
            </a:extLst>
          </p:cNvPr>
          <p:cNvSpPr/>
          <p:nvPr/>
        </p:nvSpPr>
        <p:spPr>
          <a:xfrm>
            <a:off x="9514476" y="1102432"/>
            <a:ext cx="1227326" cy="15620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4D4165C-CAC7-4F90-85A2-5E73A58070BE}"/>
              </a:ext>
            </a:extLst>
          </p:cNvPr>
          <p:cNvSpPr txBox="1"/>
          <p:nvPr/>
        </p:nvSpPr>
        <p:spPr>
          <a:xfrm rot="18554512">
            <a:off x="8296767" y="56007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271C93D-12DB-4FCA-9207-0D218A45B828}"/>
              </a:ext>
            </a:extLst>
          </p:cNvPr>
          <p:cNvSpPr txBox="1"/>
          <p:nvPr/>
        </p:nvSpPr>
        <p:spPr>
          <a:xfrm rot="18554512">
            <a:off x="8707318" y="54240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91200D2-8032-4390-9D12-C3FF04667468}"/>
              </a:ext>
            </a:extLst>
          </p:cNvPr>
          <p:cNvSpPr txBox="1"/>
          <p:nvPr/>
        </p:nvSpPr>
        <p:spPr>
          <a:xfrm rot="18554512">
            <a:off x="9117869" y="52473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35CF24A-0B79-43EA-94C5-1AA4436BF3E8}"/>
              </a:ext>
            </a:extLst>
          </p:cNvPr>
          <p:cNvSpPr txBox="1"/>
          <p:nvPr/>
        </p:nvSpPr>
        <p:spPr>
          <a:xfrm rot="18554512">
            <a:off x="9511782" y="56830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33790562-E266-479C-AE14-518393476CAB}"/>
              </a:ext>
            </a:extLst>
          </p:cNvPr>
          <p:cNvSpPr txBox="1"/>
          <p:nvPr/>
        </p:nvSpPr>
        <p:spPr>
          <a:xfrm rot="18554512">
            <a:off x="9922333" y="55063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29DBB88-D244-4228-8087-12F38B57FE83}"/>
              </a:ext>
            </a:extLst>
          </p:cNvPr>
          <p:cNvSpPr txBox="1"/>
          <p:nvPr/>
        </p:nvSpPr>
        <p:spPr>
          <a:xfrm rot="18554512">
            <a:off x="10332884" y="53296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06C8774A-3089-4E16-8673-AEE8228344AE}"/>
              </a:ext>
            </a:extLst>
          </p:cNvPr>
          <p:cNvSpPr txBox="1"/>
          <p:nvPr/>
        </p:nvSpPr>
        <p:spPr>
          <a:xfrm>
            <a:off x="6607474" y="1459780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701EF1B-3ED4-44DB-B0B5-4478EDFBAFAC}"/>
              </a:ext>
            </a:extLst>
          </p:cNvPr>
          <p:cNvSpPr txBox="1"/>
          <p:nvPr/>
        </p:nvSpPr>
        <p:spPr>
          <a:xfrm>
            <a:off x="6495394" y="2152804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8EBDAE43-26B2-4025-9CFD-5781BAA559E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898" t="7287" r="898" b="28675"/>
          <a:stretch/>
        </p:blipFill>
        <p:spPr>
          <a:xfrm>
            <a:off x="1254101" y="3326628"/>
            <a:ext cx="3902358" cy="636762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44F7159A-E627-4029-83BF-12B2D3EE0E1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79938" y="4107799"/>
            <a:ext cx="3683000" cy="574115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1DA65674-8A74-4242-9CE7-A1659B7C15CD}"/>
              </a:ext>
            </a:extLst>
          </p:cNvPr>
          <p:cNvSpPr/>
          <p:nvPr/>
        </p:nvSpPr>
        <p:spPr>
          <a:xfrm>
            <a:off x="3075677" y="3205977"/>
            <a:ext cx="1308986" cy="15620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9C9AB47-A6BD-4E39-AC04-109EF8025B66}"/>
              </a:ext>
            </a:extLst>
          </p:cNvPr>
          <p:cNvSpPr txBox="1"/>
          <p:nvPr/>
        </p:nvSpPr>
        <p:spPr>
          <a:xfrm rot="18554512">
            <a:off x="3072983" y="263998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7E1AD28-D3E8-43B4-93D7-46370F454F89}"/>
              </a:ext>
            </a:extLst>
          </p:cNvPr>
          <p:cNvSpPr txBox="1"/>
          <p:nvPr/>
        </p:nvSpPr>
        <p:spPr>
          <a:xfrm rot="18554512">
            <a:off x="3483534" y="262231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AFEE174-A327-461F-BACE-842FD0858597}"/>
              </a:ext>
            </a:extLst>
          </p:cNvPr>
          <p:cNvSpPr txBox="1"/>
          <p:nvPr/>
        </p:nvSpPr>
        <p:spPr>
          <a:xfrm rot="18554512">
            <a:off x="3894085" y="260464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C0806AE-B5EF-43AE-8E40-41385B3485AD}"/>
              </a:ext>
            </a:extLst>
          </p:cNvPr>
          <p:cNvSpPr txBox="1"/>
          <p:nvPr/>
        </p:nvSpPr>
        <p:spPr>
          <a:xfrm>
            <a:off x="490967" y="3412688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99940C35-29D1-486D-962B-91A4A30849B0}"/>
              </a:ext>
            </a:extLst>
          </p:cNvPr>
          <p:cNvSpPr txBox="1"/>
          <p:nvPr/>
        </p:nvSpPr>
        <p:spPr>
          <a:xfrm>
            <a:off x="378887" y="410571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8B8272C8-281C-4469-908F-CC58A3277C8C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9211" b="17336"/>
          <a:stretch/>
        </p:blipFill>
        <p:spPr>
          <a:xfrm>
            <a:off x="6758677" y="3678697"/>
            <a:ext cx="4218424" cy="499929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E64896F9-51DD-4A8B-8A60-E381ABE194C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67092" y="4235145"/>
            <a:ext cx="4568759" cy="502061"/>
          </a:xfrm>
          <a:prstGeom prst="rect">
            <a:avLst/>
          </a:prstGeom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AE2E3A81-B84D-4616-AE56-D5C0B50739EF}"/>
              </a:ext>
            </a:extLst>
          </p:cNvPr>
          <p:cNvSpPr/>
          <p:nvPr/>
        </p:nvSpPr>
        <p:spPr>
          <a:xfrm>
            <a:off x="8178679" y="3556560"/>
            <a:ext cx="979641" cy="136134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9672F216-A70D-4B7A-BBAC-665EDACC37F3}"/>
              </a:ext>
            </a:extLst>
          </p:cNvPr>
          <p:cNvSpPr txBox="1"/>
          <p:nvPr/>
        </p:nvSpPr>
        <p:spPr>
          <a:xfrm rot="18554512">
            <a:off x="7987886" y="295466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F3689A95-2D59-4C89-A52C-A368C4ED3BA4}"/>
              </a:ext>
            </a:extLst>
          </p:cNvPr>
          <p:cNvSpPr txBox="1"/>
          <p:nvPr/>
        </p:nvSpPr>
        <p:spPr>
          <a:xfrm rot="18554512">
            <a:off x="8398437" y="293698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7611E0B7-E787-4837-8064-7DBC9F96F47A}"/>
              </a:ext>
            </a:extLst>
          </p:cNvPr>
          <p:cNvSpPr txBox="1"/>
          <p:nvPr/>
        </p:nvSpPr>
        <p:spPr>
          <a:xfrm rot="18554512">
            <a:off x="8808988" y="291931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D6ECAF1-CD9E-429D-99BB-C044149B721F}"/>
              </a:ext>
            </a:extLst>
          </p:cNvPr>
          <p:cNvSpPr txBox="1"/>
          <p:nvPr/>
        </p:nvSpPr>
        <p:spPr>
          <a:xfrm>
            <a:off x="5733181" y="3603355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DEE1186-B013-4BC4-8CA1-E50F8737068A}"/>
              </a:ext>
            </a:extLst>
          </p:cNvPr>
          <p:cNvSpPr txBox="1"/>
          <p:nvPr/>
        </p:nvSpPr>
        <p:spPr>
          <a:xfrm>
            <a:off x="5621101" y="4296379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90321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3E694E92-BF9A-4501-991B-B5DEDF63882C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78D9312E-186C-45E6-843B-3D0A46F89B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73" t="-7071"/>
          <a:stretch/>
        </p:blipFill>
        <p:spPr>
          <a:xfrm>
            <a:off x="957835" y="1304554"/>
            <a:ext cx="5013960" cy="554518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7E215DF-9CC5-40CC-9AEA-90290BCD4769}"/>
              </a:ext>
            </a:extLst>
          </p:cNvPr>
          <p:cNvSpPr txBox="1"/>
          <p:nvPr/>
        </p:nvSpPr>
        <p:spPr>
          <a:xfrm>
            <a:off x="217969" y="1381606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D9EB3FC-E62B-48DE-9D56-0046A367C7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4127" y="1925758"/>
            <a:ext cx="4780483" cy="63964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4043209D-14B7-492E-8456-5F2A77970D13}"/>
              </a:ext>
            </a:extLst>
          </p:cNvPr>
          <p:cNvSpPr txBox="1"/>
          <p:nvPr/>
        </p:nvSpPr>
        <p:spPr>
          <a:xfrm>
            <a:off x="198476" y="203277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690598F7-6EDD-4E49-AC05-2E045E09E435}"/>
              </a:ext>
            </a:extLst>
          </p:cNvPr>
          <p:cNvSpPr/>
          <p:nvPr/>
        </p:nvSpPr>
        <p:spPr>
          <a:xfrm>
            <a:off x="2557695" y="1247088"/>
            <a:ext cx="1117600" cy="135733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79BFDF9-CE97-48DF-809A-B49E95E233C6}"/>
              </a:ext>
            </a:extLst>
          </p:cNvPr>
          <p:cNvSpPr txBox="1"/>
          <p:nvPr/>
        </p:nvSpPr>
        <p:spPr>
          <a:xfrm rot="18554512">
            <a:off x="2503081" y="62921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864E2D2-31D4-4CA0-B3A7-7C59E55076A4}"/>
              </a:ext>
            </a:extLst>
          </p:cNvPr>
          <p:cNvSpPr txBox="1"/>
          <p:nvPr/>
        </p:nvSpPr>
        <p:spPr>
          <a:xfrm rot="18554512">
            <a:off x="2913632" y="61154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07718F3-4D34-449D-843E-F698FEC7DBA8}"/>
              </a:ext>
            </a:extLst>
          </p:cNvPr>
          <p:cNvSpPr txBox="1"/>
          <p:nvPr/>
        </p:nvSpPr>
        <p:spPr>
          <a:xfrm rot="18554512">
            <a:off x="3324183" y="59387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D9AAB284-2DB2-4348-8976-7EE11266BC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79976" y="3367803"/>
            <a:ext cx="3227244" cy="583739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419919A0-0103-45C2-8B79-75A8CA539544}"/>
              </a:ext>
            </a:extLst>
          </p:cNvPr>
          <p:cNvSpPr txBox="1"/>
          <p:nvPr/>
        </p:nvSpPr>
        <p:spPr>
          <a:xfrm>
            <a:off x="501125" y="3456769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FD45F0C-1520-49D4-BFB9-DF715275B012}"/>
              </a:ext>
            </a:extLst>
          </p:cNvPr>
          <p:cNvSpPr txBox="1"/>
          <p:nvPr/>
        </p:nvSpPr>
        <p:spPr>
          <a:xfrm>
            <a:off x="481632" y="410793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9500195A-4F1A-432E-B87A-634C8AB6C2C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4027" y="4105566"/>
            <a:ext cx="3107693" cy="609352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FD16AE1C-CBC2-4141-86AF-D0C2CA206DF5}"/>
              </a:ext>
            </a:extLst>
          </p:cNvPr>
          <p:cNvSpPr/>
          <p:nvPr/>
        </p:nvSpPr>
        <p:spPr>
          <a:xfrm>
            <a:off x="2525422" y="3308350"/>
            <a:ext cx="1117600" cy="15112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A7F7045F-9FE8-4532-A53E-11830DD387D4}"/>
              </a:ext>
            </a:extLst>
          </p:cNvPr>
          <p:cNvSpPr/>
          <p:nvPr/>
        </p:nvSpPr>
        <p:spPr>
          <a:xfrm>
            <a:off x="3703571" y="3308349"/>
            <a:ext cx="1007590" cy="15112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919655B-A6A7-45F4-BE50-F6E5CC6C02EB}"/>
              </a:ext>
            </a:extLst>
          </p:cNvPr>
          <p:cNvSpPr txBox="1"/>
          <p:nvPr/>
        </p:nvSpPr>
        <p:spPr>
          <a:xfrm rot="18554512">
            <a:off x="2369732" y="268764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16BCE15-1233-4AB6-A4F6-F71BE57AA1B5}"/>
              </a:ext>
            </a:extLst>
          </p:cNvPr>
          <p:cNvSpPr txBox="1"/>
          <p:nvPr/>
        </p:nvSpPr>
        <p:spPr>
          <a:xfrm rot="18554512">
            <a:off x="2780283" y="266997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6E10076-05B7-48DA-AA75-04563033EE99}"/>
              </a:ext>
            </a:extLst>
          </p:cNvPr>
          <p:cNvSpPr txBox="1"/>
          <p:nvPr/>
        </p:nvSpPr>
        <p:spPr>
          <a:xfrm rot="18554512">
            <a:off x="3190834" y="265230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DB1DD23-96F6-49AD-9B35-475090E97AE4}"/>
              </a:ext>
            </a:extLst>
          </p:cNvPr>
          <p:cNvSpPr txBox="1"/>
          <p:nvPr/>
        </p:nvSpPr>
        <p:spPr>
          <a:xfrm rot="18554512">
            <a:off x="3542401" y="264047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762562C-0BB0-4706-B2F6-FE7ED1FBD71C}"/>
              </a:ext>
            </a:extLst>
          </p:cNvPr>
          <p:cNvSpPr txBox="1"/>
          <p:nvPr/>
        </p:nvSpPr>
        <p:spPr>
          <a:xfrm rot="18554512">
            <a:off x="3952952" y="262280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127DE29-6D80-463B-B59F-68E2C8B2D4EA}"/>
              </a:ext>
            </a:extLst>
          </p:cNvPr>
          <p:cNvSpPr txBox="1"/>
          <p:nvPr/>
        </p:nvSpPr>
        <p:spPr>
          <a:xfrm rot="18554512">
            <a:off x="4363503" y="260513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562FCE63-0706-468E-968E-7489B5FDD95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03950" y="3292273"/>
            <a:ext cx="5041900" cy="770065"/>
          </a:xfrm>
          <a:prstGeom prst="rect">
            <a:avLst/>
          </a:prstGeom>
        </p:spPr>
      </p:pic>
      <p:sp>
        <p:nvSpPr>
          <p:cNvPr id="34" name="文本框 33">
            <a:extLst>
              <a:ext uri="{FF2B5EF4-FFF2-40B4-BE49-F238E27FC236}">
                <a16:creationId xmlns:a16="http://schemas.microsoft.com/office/drawing/2014/main" id="{179FB114-B388-46BE-94EC-C5069D3A153D}"/>
              </a:ext>
            </a:extLst>
          </p:cNvPr>
          <p:cNvSpPr txBox="1"/>
          <p:nvPr/>
        </p:nvSpPr>
        <p:spPr>
          <a:xfrm>
            <a:off x="5155304" y="3545669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BDF0C54-B7E6-4B9B-A5DB-1D2F44EE20DE}"/>
              </a:ext>
            </a:extLst>
          </p:cNvPr>
          <p:cNvSpPr txBox="1"/>
          <p:nvPr/>
        </p:nvSpPr>
        <p:spPr>
          <a:xfrm>
            <a:off x="5135811" y="419683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A73B02BC-E8C5-42EF-B135-30BE76205EE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03950" y="4169365"/>
            <a:ext cx="4968875" cy="424272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471F7B1E-CD3E-4934-A9B5-41900BDA4374}"/>
              </a:ext>
            </a:extLst>
          </p:cNvPr>
          <p:cNvSpPr/>
          <p:nvPr/>
        </p:nvSpPr>
        <p:spPr>
          <a:xfrm>
            <a:off x="7942904" y="3249121"/>
            <a:ext cx="1007590" cy="151129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8407867-287A-448C-AC3B-3486341A3463}"/>
              </a:ext>
            </a:extLst>
          </p:cNvPr>
          <p:cNvSpPr txBox="1"/>
          <p:nvPr/>
        </p:nvSpPr>
        <p:spPr>
          <a:xfrm rot="18554512">
            <a:off x="7742551" y="257327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E7C502F-C2A5-4AB1-845D-38AEE58000A0}"/>
              </a:ext>
            </a:extLst>
          </p:cNvPr>
          <p:cNvSpPr txBox="1"/>
          <p:nvPr/>
        </p:nvSpPr>
        <p:spPr>
          <a:xfrm rot="18554512">
            <a:off x="8153102" y="255560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6E64D1B-925E-4CB5-BD12-CB1977964955}"/>
              </a:ext>
            </a:extLst>
          </p:cNvPr>
          <p:cNvSpPr txBox="1"/>
          <p:nvPr/>
        </p:nvSpPr>
        <p:spPr>
          <a:xfrm rot="18554512">
            <a:off x="8563653" y="253792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75370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ECB39CF-07A9-4A01-AF31-A0321FE8C8E1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356B292-4650-44A8-A88C-EB2365890C4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7006"/>
          <a:stretch/>
        </p:blipFill>
        <p:spPr>
          <a:xfrm>
            <a:off x="1203325" y="1104901"/>
            <a:ext cx="4359275" cy="54314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CDFD4525-AD87-4CF5-B55F-5C5CB75574C0}"/>
              </a:ext>
            </a:extLst>
          </p:cNvPr>
          <p:cNvSpPr txBox="1"/>
          <p:nvPr/>
        </p:nvSpPr>
        <p:spPr>
          <a:xfrm>
            <a:off x="251228" y="110490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36DFAB2-96BD-4844-8269-E35B6E1EF45D}"/>
              </a:ext>
            </a:extLst>
          </p:cNvPr>
          <p:cNvSpPr txBox="1"/>
          <p:nvPr/>
        </p:nvSpPr>
        <p:spPr>
          <a:xfrm>
            <a:off x="139148" y="179792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E20AB037-C113-4EB4-8B21-33AB7D8A7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03325" y="1869622"/>
            <a:ext cx="4403725" cy="314552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F99AFE61-AFA9-4642-BC8C-B2CE3AC78D7A}"/>
              </a:ext>
            </a:extLst>
          </p:cNvPr>
          <p:cNvSpPr/>
          <p:nvPr/>
        </p:nvSpPr>
        <p:spPr>
          <a:xfrm>
            <a:off x="3422650" y="1028701"/>
            <a:ext cx="927100" cy="135255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37FCB62-EE3D-498D-9544-4CB1C8A9B9CA}"/>
              </a:ext>
            </a:extLst>
          </p:cNvPr>
          <p:cNvSpPr txBox="1"/>
          <p:nvPr/>
        </p:nvSpPr>
        <p:spPr>
          <a:xfrm rot="18554512">
            <a:off x="3227293" y="455393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94D974B-4CC1-440C-8D10-7F6D8AC46E30}"/>
              </a:ext>
            </a:extLst>
          </p:cNvPr>
          <p:cNvSpPr txBox="1"/>
          <p:nvPr/>
        </p:nvSpPr>
        <p:spPr>
          <a:xfrm rot="18554512">
            <a:off x="3637844" y="43772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99632A4-46DE-403C-8500-B2AA4CB7FA05}"/>
              </a:ext>
            </a:extLst>
          </p:cNvPr>
          <p:cNvSpPr txBox="1"/>
          <p:nvPr/>
        </p:nvSpPr>
        <p:spPr>
          <a:xfrm rot="18554512">
            <a:off x="4048395" y="42005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9855F4F3-2000-4D15-995C-4A085E1958A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30065"/>
          <a:stretch/>
        </p:blipFill>
        <p:spPr>
          <a:xfrm>
            <a:off x="1203325" y="2854152"/>
            <a:ext cx="4503768" cy="679448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12BB12E6-2CF1-456B-8B1D-40E38B4E6321}"/>
              </a:ext>
            </a:extLst>
          </p:cNvPr>
          <p:cNvSpPr txBox="1"/>
          <p:nvPr/>
        </p:nvSpPr>
        <p:spPr>
          <a:xfrm>
            <a:off x="339754" y="300355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1β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409E967-B4B0-4530-92A1-199590C654AC}"/>
              </a:ext>
            </a:extLst>
          </p:cNvPr>
          <p:cNvSpPr txBox="1"/>
          <p:nvPr/>
        </p:nvSpPr>
        <p:spPr>
          <a:xfrm>
            <a:off x="227674" y="369657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47DCB3B7-19F1-4D8F-AA32-E0F6DFDA94F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5962" y="3761473"/>
            <a:ext cx="4641131" cy="591278"/>
          </a:xfrm>
          <a:prstGeom prst="rect">
            <a:avLst/>
          </a:prstGeom>
        </p:spPr>
      </p:pic>
      <p:sp>
        <p:nvSpPr>
          <p:cNvPr id="31" name="矩形 30">
            <a:extLst>
              <a:ext uri="{FF2B5EF4-FFF2-40B4-BE49-F238E27FC236}">
                <a16:creationId xmlns:a16="http://schemas.microsoft.com/office/drawing/2014/main" id="{AB25F6FB-8946-4A1C-B5C6-2402D3772186}"/>
              </a:ext>
            </a:extLst>
          </p:cNvPr>
          <p:cNvSpPr/>
          <p:nvPr/>
        </p:nvSpPr>
        <p:spPr>
          <a:xfrm>
            <a:off x="3752850" y="2762250"/>
            <a:ext cx="1086062" cy="166370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B762153C-7C1E-4241-8A2A-C7B20228F71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37195"/>
          <a:stretch/>
        </p:blipFill>
        <p:spPr>
          <a:xfrm>
            <a:off x="6611661" y="1119929"/>
            <a:ext cx="3715025" cy="918375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5920DCBB-65F9-4BB6-B3C8-A0B840A8BFB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08325" y="2128125"/>
            <a:ext cx="3537425" cy="539848"/>
          </a:xfrm>
          <a:prstGeom prst="rect">
            <a:avLst/>
          </a:prstGeom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3A09997B-78B9-482E-A171-01279CA70A0F}"/>
              </a:ext>
            </a:extLst>
          </p:cNvPr>
          <p:cNvSpPr/>
          <p:nvPr/>
        </p:nvSpPr>
        <p:spPr>
          <a:xfrm>
            <a:off x="9074150" y="1073228"/>
            <a:ext cx="1252536" cy="154932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409AB60-9C09-406C-937C-D89E8973270D}"/>
              </a:ext>
            </a:extLst>
          </p:cNvPr>
          <p:cNvSpPr txBox="1"/>
          <p:nvPr/>
        </p:nvSpPr>
        <p:spPr>
          <a:xfrm rot="18554512">
            <a:off x="8961273" y="57352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7709D0F-9F73-482E-BBCE-6A1DAA468F34}"/>
              </a:ext>
            </a:extLst>
          </p:cNvPr>
          <p:cNvSpPr txBox="1"/>
          <p:nvPr/>
        </p:nvSpPr>
        <p:spPr>
          <a:xfrm rot="18554512">
            <a:off x="9371824" y="55584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36057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A386FD6-159A-457F-A0D2-DE1398086FC2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50E04117-C8AE-4665-8ED1-54D807B4A0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1830" y="1200095"/>
            <a:ext cx="4589394" cy="69732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19335E1B-9094-4451-AC36-8B843A752C85}"/>
              </a:ext>
            </a:extLst>
          </p:cNvPr>
          <p:cNvSpPr txBox="1"/>
          <p:nvPr/>
        </p:nvSpPr>
        <p:spPr>
          <a:xfrm>
            <a:off x="251228" y="143510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16D6CE4-4248-4F77-B30B-046270F27759}"/>
              </a:ext>
            </a:extLst>
          </p:cNvPr>
          <p:cNvSpPr txBox="1"/>
          <p:nvPr/>
        </p:nvSpPr>
        <p:spPr>
          <a:xfrm>
            <a:off x="139148" y="212812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487CA8C-9C74-4AE9-A167-D2A59B46DD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599" y="1994071"/>
            <a:ext cx="5057401" cy="454087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FB25F7B7-F161-46E7-80B8-DC853A8AFC8A}"/>
              </a:ext>
            </a:extLst>
          </p:cNvPr>
          <p:cNvSpPr/>
          <p:nvPr/>
        </p:nvSpPr>
        <p:spPr>
          <a:xfrm>
            <a:off x="3879780" y="1128158"/>
            <a:ext cx="927100" cy="135255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E68F346-D15D-436D-8C4D-735198B27321}"/>
              </a:ext>
            </a:extLst>
          </p:cNvPr>
          <p:cNvSpPr txBox="1"/>
          <p:nvPr/>
        </p:nvSpPr>
        <p:spPr>
          <a:xfrm rot="18554512">
            <a:off x="3684423" y="55485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740146D-74B6-4E46-BB4D-EDDE18003D2A}"/>
              </a:ext>
            </a:extLst>
          </p:cNvPr>
          <p:cNvSpPr txBox="1"/>
          <p:nvPr/>
        </p:nvSpPr>
        <p:spPr>
          <a:xfrm rot="18554512">
            <a:off x="4094974" y="53717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67F29B5-5C0A-49C5-A8BE-45811145D34A}"/>
              </a:ext>
            </a:extLst>
          </p:cNvPr>
          <p:cNvSpPr txBox="1"/>
          <p:nvPr/>
        </p:nvSpPr>
        <p:spPr>
          <a:xfrm rot="18554512">
            <a:off x="4505525" y="519508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712B7748-753E-4853-AD5D-BC137A26B8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3191" y="3139625"/>
            <a:ext cx="4847851" cy="85153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3D292157-923E-48B0-BAFD-97ACCB674A8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6991" y="4136713"/>
            <a:ext cx="4581151" cy="573997"/>
          </a:xfrm>
          <a:prstGeom prst="rect">
            <a:avLst/>
          </a:prstGeom>
        </p:spPr>
      </p:pic>
      <p:sp>
        <p:nvSpPr>
          <p:cNvPr id="21" name="矩形 20">
            <a:extLst>
              <a:ext uri="{FF2B5EF4-FFF2-40B4-BE49-F238E27FC236}">
                <a16:creationId xmlns:a16="http://schemas.microsoft.com/office/drawing/2014/main" id="{B6D66E81-6412-4A6E-B3CC-BB13B6FA5D55}"/>
              </a:ext>
            </a:extLst>
          </p:cNvPr>
          <p:cNvSpPr/>
          <p:nvPr/>
        </p:nvSpPr>
        <p:spPr>
          <a:xfrm>
            <a:off x="3894892" y="2988386"/>
            <a:ext cx="996880" cy="205422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29DF1BB-6710-427B-9AAF-FC11643628C5}"/>
              </a:ext>
            </a:extLst>
          </p:cNvPr>
          <p:cNvSpPr txBox="1"/>
          <p:nvPr/>
        </p:nvSpPr>
        <p:spPr>
          <a:xfrm>
            <a:off x="251228" y="3467793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D8F2D18-32E6-4311-A843-F4E6AA95146C}"/>
              </a:ext>
            </a:extLst>
          </p:cNvPr>
          <p:cNvSpPr txBox="1"/>
          <p:nvPr/>
        </p:nvSpPr>
        <p:spPr>
          <a:xfrm>
            <a:off x="139148" y="4160817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3BDEA02A-8E8E-4227-82DF-ACB352055C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14681" y="1163499"/>
            <a:ext cx="3699420" cy="983235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A1B6270D-F892-4988-8A42-064414EA5ED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673970" y="2221114"/>
            <a:ext cx="3343275" cy="649061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C687EF2A-6C11-492F-9529-8C22433AA650}"/>
              </a:ext>
            </a:extLst>
          </p:cNvPr>
          <p:cNvSpPr/>
          <p:nvPr/>
        </p:nvSpPr>
        <p:spPr>
          <a:xfrm>
            <a:off x="7899400" y="1026237"/>
            <a:ext cx="1130299" cy="196215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D7703A5-E30D-46CD-BB70-EE223D2A481A}"/>
              </a:ext>
            </a:extLst>
          </p:cNvPr>
          <p:cNvSpPr txBox="1"/>
          <p:nvPr/>
        </p:nvSpPr>
        <p:spPr>
          <a:xfrm rot="18554512">
            <a:off x="7729373" y="515812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2581F0EB-7FAD-4441-A89C-3E0F932A711A}"/>
              </a:ext>
            </a:extLst>
          </p:cNvPr>
          <p:cNvSpPr txBox="1"/>
          <p:nvPr/>
        </p:nvSpPr>
        <p:spPr>
          <a:xfrm rot="18554512">
            <a:off x="8139924" y="49814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AF536795-7E44-4E83-A8D5-BDA45CC95051}"/>
              </a:ext>
            </a:extLst>
          </p:cNvPr>
          <p:cNvSpPr txBox="1"/>
          <p:nvPr/>
        </p:nvSpPr>
        <p:spPr>
          <a:xfrm rot="18554512">
            <a:off x="8550475" y="480470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58E4E21C-4365-4CD1-8BB2-50EE15BBE055}"/>
              </a:ext>
            </a:extLst>
          </p:cNvPr>
          <p:cNvSpPr txBox="1"/>
          <p:nvPr/>
        </p:nvSpPr>
        <p:spPr>
          <a:xfrm>
            <a:off x="6763192" y="1528091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L-6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073C063-DBB8-4F55-94FE-BF90639DE385}"/>
              </a:ext>
            </a:extLst>
          </p:cNvPr>
          <p:cNvSpPr txBox="1"/>
          <p:nvPr/>
        </p:nvSpPr>
        <p:spPr>
          <a:xfrm>
            <a:off x="6651112" y="2221115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012880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9C59CEC-6947-4C7C-835D-9B332D87ACAF}"/>
              </a:ext>
            </a:extLst>
          </p:cNvPr>
          <p:cNvSpPr txBox="1"/>
          <p:nvPr/>
        </p:nvSpPr>
        <p:spPr>
          <a:xfrm>
            <a:off x="139148" y="79513"/>
            <a:ext cx="25180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weeks of age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84367836-7CE4-4D29-9672-5A5EF83129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8941" y="3836102"/>
            <a:ext cx="4276725" cy="47304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BC02ADF-2B8C-43A6-BFBA-FCAA0DB42D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8941" y="4485410"/>
            <a:ext cx="4323191" cy="526980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FF9355BF-54B5-4DDB-A843-CB35440FE605}"/>
              </a:ext>
            </a:extLst>
          </p:cNvPr>
          <p:cNvSpPr/>
          <p:nvPr/>
        </p:nvSpPr>
        <p:spPr>
          <a:xfrm>
            <a:off x="5036812" y="3788477"/>
            <a:ext cx="857250" cy="129693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65CC70D-E59C-4561-913C-B3F64A42AEFA}"/>
              </a:ext>
            </a:extLst>
          </p:cNvPr>
          <p:cNvSpPr txBox="1"/>
          <p:nvPr/>
        </p:nvSpPr>
        <p:spPr>
          <a:xfrm rot="18554512">
            <a:off x="4884610" y="3217384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308164E-2BC9-46C4-AADF-00CFFBBBD92A}"/>
              </a:ext>
            </a:extLst>
          </p:cNvPr>
          <p:cNvSpPr txBox="1"/>
          <p:nvPr/>
        </p:nvSpPr>
        <p:spPr>
          <a:xfrm rot="18554512">
            <a:off x="5172742" y="318093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6E2C2D78-AB7A-4FB4-82A0-B9F8570B3529}"/>
              </a:ext>
            </a:extLst>
          </p:cNvPr>
          <p:cNvSpPr txBox="1"/>
          <p:nvPr/>
        </p:nvSpPr>
        <p:spPr>
          <a:xfrm rot="18554512">
            <a:off x="5445836" y="324025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48D9822-6071-4CB5-B270-B985E2A73FBF}"/>
              </a:ext>
            </a:extLst>
          </p:cNvPr>
          <p:cNvSpPr/>
          <p:nvPr/>
        </p:nvSpPr>
        <p:spPr>
          <a:xfrm>
            <a:off x="5894062" y="3788477"/>
            <a:ext cx="857250" cy="129693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F0162C1-FA9B-4A56-9E91-946C266B4BDD}"/>
              </a:ext>
            </a:extLst>
          </p:cNvPr>
          <p:cNvSpPr txBox="1"/>
          <p:nvPr/>
        </p:nvSpPr>
        <p:spPr>
          <a:xfrm rot="18554512">
            <a:off x="5846548" y="3244525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12E2D72-58DD-4551-98A0-AC63921972A1}"/>
              </a:ext>
            </a:extLst>
          </p:cNvPr>
          <p:cNvSpPr txBox="1"/>
          <p:nvPr/>
        </p:nvSpPr>
        <p:spPr>
          <a:xfrm rot="18554512">
            <a:off x="6174338" y="3222419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9B7A7E7-FE4C-413A-B863-46A4C80BAA91}"/>
              </a:ext>
            </a:extLst>
          </p:cNvPr>
          <p:cNvSpPr txBox="1"/>
          <p:nvPr/>
        </p:nvSpPr>
        <p:spPr>
          <a:xfrm rot="18554512">
            <a:off x="6447432" y="321217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AB5AACF2-D996-4121-AFDF-8FDB198AE6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08157" y="1368737"/>
            <a:ext cx="4052262" cy="63152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6DFCFB28-834B-487E-8D6E-E238691D8AF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2757" y="2155419"/>
            <a:ext cx="3889375" cy="631522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6905A5C1-250B-417E-AA01-2F7816B02937}"/>
              </a:ext>
            </a:extLst>
          </p:cNvPr>
          <p:cNvSpPr/>
          <p:nvPr/>
        </p:nvSpPr>
        <p:spPr>
          <a:xfrm>
            <a:off x="3475091" y="1340659"/>
            <a:ext cx="1357633" cy="154573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115FEFC-25CC-4114-85E7-8C56A6561A21}"/>
              </a:ext>
            </a:extLst>
          </p:cNvPr>
          <p:cNvSpPr txBox="1"/>
          <p:nvPr/>
        </p:nvSpPr>
        <p:spPr>
          <a:xfrm rot="18554512">
            <a:off x="3322890" y="769566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+S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029E99E9-9BBD-44B2-8016-8F6D62DD04C2}"/>
              </a:ext>
            </a:extLst>
          </p:cNvPr>
          <p:cNvSpPr txBox="1"/>
          <p:nvPr/>
        </p:nvSpPr>
        <p:spPr>
          <a:xfrm rot="18554512">
            <a:off x="3834228" y="682507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23AAB00-57E3-4716-B780-4F67C0DCF662}"/>
              </a:ext>
            </a:extLst>
          </p:cNvPr>
          <p:cNvSpPr txBox="1"/>
          <p:nvPr/>
        </p:nvSpPr>
        <p:spPr>
          <a:xfrm rot="18554512">
            <a:off x="4381484" y="705041"/>
            <a:ext cx="793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389FD08-9066-42D9-BFAB-F61AA827FDAE}"/>
              </a:ext>
            </a:extLst>
          </p:cNvPr>
          <p:cNvSpPr txBox="1"/>
          <p:nvPr/>
        </p:nvSpPr>
        <p:spPr>
          <a:xfrm>
            <a:off x="1905703" y="3844573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en-US" altLang="zh-CN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74061F0-220C-434A-8188-63661DD30D24}"/>
              </a:ext>
            </a:extLst>
          </p:cNvPr>
          <p:cNvSpPr txBox="1"/>
          <p:nvPr/>
        </p:nvSpPr>
        <p:spPr>
          <a:xfrm>
            <a:off x="1646574" y="4507866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A5EBFBF-7CB5-4B16-95C7-58499F4EFA94}"/>
              </a:ext>
            </a:extLst>
          </p:cNvPr>
          <p:cNvSpPr txBox="1"/>
          <p:nvPr/>
        </p:nvSpPr>
        <p:spPr>
          <a:xfrm>
            <a:off x="2107093" y="1590339"/>
            <a:ext cx="751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Inos</a:t>
            </a:r>
            <a:endParaRPr lang="en-US" altLang="zh-CN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3FC2974-23E8-48C5-A27C-B0B391E01894}"/>
              </a:ext>
            </a:extLst>
          </p:cNvPr>
          <p:cNvSpPr txBox="1"/>
          <p:nvPr/>
        </p:nvSpPr>
        <p:spPr>
          <a:xfrm>
            <a:off x="1847964" y="2253632"/>
            <a:ext cx="975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β-Actin</a:t>
            </a:r>
            <a:endParaRPr lang="zh-CN" altLang="en-US" b="1" dirty="0"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9581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>
          <a:solidFill>
            <a:schemeClr val="accent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6"/>
        </a:lnRef>
        <a:fillRef idx="1">
          <a:schemeClr val="lt1"/>
        </a:fillRef>
        <a:effectRef idx="0">
          <a:schemeClr val="accent6"/>
        </a:effectRef>
        <a:fontRef idx="minor">
          <a:schemeClr val="dk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6</TotalTime>
  <Words>266</Words>
  <Application>Microsoft Office PowerPoint</Application>
  <PresentationFormat>宽屏</PresentationFormat>
  <Paragraphs>169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4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子睿</dc:creator>
  <cp:lastModifiedBy>子睿</cp:lastModifiedBy>
  <cp:revision>2</cp:revision>
  <dcterms:created xsi:type="dcterms:W3CDTF">2021-12-01T08:19:55Z</dcterms:created>
  <dcterms:modified xsi:type="dcterms:W3CDTF">2021-12-01T14:06:09Z</dcterms:modified>
</cp:coreProperties>
</file>